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96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34AE51FA-04DE-49F4-8EC1-1771469B14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xmlns="" id="{61FB256D-08C7-4C3A-BFCC-A82EBC1A155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DCD86BE7-3E6C-472B-BA0C-60AB3DE1A5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6F92C71-4297-4E46-8B03-4E20458F3D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EB83445-D41A-4B6A-A93E-C7655D6A0C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922151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3B2C63A-41C9-4404-B71C-51C7DA924D1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D0988CF4-62E3-4299-AD29-68FFC738B9D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A10E0382-15D8-4FDF-BDED-213BB5C67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76A57597-6C7E-4847-8ABC-9AB627264A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744A6338-8BFD-4E8B-8842-D0FBFB24BE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9944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xmlns="" id="{10D2477D-5F87-4270-8992-0770587174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xmlns="" id="{CF93ED23-4DE7-4FE0-9B89-2B1CB7CF8A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EDA0E0A7-134A-4A7D-AA44-7E27E7107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FF25BEEC-B4AD-4950-85A1-2FDEF915F2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91C25E23-A3FE-4B9C-B844-F90AB2B07F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4385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56310C65-2D3A-4EEE-B8CE-55D0DDB692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D485A6BC-9F4C-4BC5-AF90-506586AC99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1B72BDBF-27FA-4E42-89CC-5E5FE7BF4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623FF62E-18CD-4F8F-A984-8608EE89CE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461361DB-3AB0-4E74-9566-832FFB195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72573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F6057DB1-0F12-4B8C-B89D-16BE1334F23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ED2A01EC-B801-4F16-8A54-921C1B23ADC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54A3EA7F-E7A2-45B6-9580-002B9248F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3C687669-CD87-4781-B871-20AF170201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84BF3974-E714-4307-915F-9DD5481743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9908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D1322E6-F6ED-4DFD-9EFE-DE44C7078B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9541263B-5F4F-4B98-B084-CF7EFA8397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16588C63-3823-44EE-AB30-ACFB0F364D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5AC8C428-1673-47E5-BC17-1DA74FB3A8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80D98A14-63E2-4143-83EA-BD24F59244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2BE58C2F-70A1-4474-87EB-CCFFBC194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471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18A5C06-2D3A-428E-BDCC-13B79854A8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167E5C29-D161-4544-B3D2-4AD7940692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xmlns="" id="{8CA30ECA-5BFF-47F8-9395-1BB3ADDBF21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xmlns="" id="{DAB278E7-4A0D-4EEE-8794-A79372F1D95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xmlns="" id="{413DF88B-F8B3-4BD0-8866-FB06BE7E6C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xmlns="" id="{6051CF2B-D417-4989-B887-B5F7FB46C6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xmlns="" id="{E329CE4C-3C81-456B-BB86-B0AC444348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xmlns="" id="{4FCB094E-BE9E-4BD6-A196-629D814B68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90241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EBCC69AD-293B-47EA-8A50-A99E389AC8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xmlns="" id="{E91F146A-C522-4764-A75A-87CE56B46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xmlns="" id="{FDD099EC-DF18-44F0-A1B6-875C4961C2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xmlns="" id="{E92C3872-C498-48A9-880E-275A0C6C46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868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xmlns="" id="{BB3ACE77-63F5-43D2-B323-5FF1673077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xmlns="" id="{DFE27331-3E55-4872-B523-B8D982B92F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xmlns="" id="{8C646A16-4CE9-4833-B9AB-3B305D44A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97040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2EBE3A48-A80D-48FE-BF68-120DE3A72C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xmlns="" id="{0488E50B-AD0C-4AEB-AF6A-C4D5D4D02E9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625EF8DB-2041-42A7-BF61-C989BDE6855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585C1A07-EA32-4BA6-999E-A896D46E1A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0409910B-CDD7-4F33-98B4-FD622B877C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CC5471E1-9FD8-4E25-A70A-FF1915B862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73645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xmlns="" id="{7E8DA731-1328-4B6D-8484-7D69839695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xmlns="" id="{517CB307-C944-4155-B12B-86723273C4A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xmlns="" id="{23BB9FC9-8795-42D5-A07A-F2327AEA6EA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xmlns="" id="{E44281A7-C419-4F5F-8D8C-CF28EC1EE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xmlns="" id="{EED15542-288E-426F-8878-3A63070723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xmlns="" id="{D1A62CA9-7E1E-48C5-BB33-41A9A9B46C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1980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xmlns="" id="{3AC33B6B-98E6-492F-9F98-D061CC3AABD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xmlns="" id="{04BF7D91-9210-4847-B13A-C42FA985FB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xmlns="" id="{3D6245FF-306F-467F-BFBC-2DA50E0151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317AD8-30DB-4681-BDBE-7C384D7A2552}" type="datetimeFigureOut">
              <a:rPr kumimoji="1" lang="ja-JP" altLang="en-US" smtClean="0"/>
              <a:t>2022/3/2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xmlns="" id="{2D1669A0-7473-4A94-B4BB-6A65091F9F4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xmlns="" id="{6879B056-00A5-40B4-9D8A-7E5293F1612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58AAAD-87A3-4BD6-9B57-ED6D4ED2E3E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0784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xmlns="" id="{2DC02CFB-84AB-41DD-A25F-67C27D03A05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107" y="817951"/>
            <a:ext cx="11811786" cy="3487563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xmlns="" id="{5E15914A-F51D-4A73-A073-7E22D066A03F}"/>
              </a:ext>
            </a:extLst>
          </p:cNvPr>
          <p:cNvSpPr txBox="1"/>
          <p:nvPr/>
        </p:nvSpPr>
        <p:spPr>
          <a:xfrm>
            <a:off x="380215" y="5030246"/>
            <a:ext cx="11621678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sz="1400" b="1" dirty="0" smtClean="0"/>
              <a:t>Figure </a:t>
            </a:r>
            <a:r>
              <a:rPr kumimoji="1" lang="en-US" altLang="ja-JP" sz="1400" b="1" dirty="0"/>
              <a:t>S2.  </a:t>
            </a:r>
            <a:r>
              <a:rPr kumimoji="1" lang="en-US" altLang="ja-JP" sz="1400" dirty="0"/>
              <a:t>Cumulative proportion of children who developed non-severe and severe virus-specific LRTI.</a:t>
            </a:r>
          </a:p>
          <a:p>
            <a:pPr>
              <a:lnSpc>
                <a:spcPct val="150000"/>
              </a:lnSpc>
            </a:pPr>
            <a:endParaRPr kumimoji="1" lang="en-US" altLang="ja-JP" sz="1400" dirty="0"/>
          </a:p>
          <a:p>
            <a:pPr>
              <a:lnSpc>
                <a:spcPct val="150000"/>
              </a:lnSpc>
            </a:pPr>
            <a:r>
              <a:rPr kumimoji="1" lang="en-US" altLang="ja-JP" sz="1400" dirty="0"/>
              <a:t>Abbreviation: LRTI, lower respiratory tract infection; </a:t>
            </a:r>
            <a:r>
              <a:rPr kumimoji="1" lang="en-US" altLang="ja-JP" sz="1400" dirty="0" err="1"/>
              <a:t>AdV</a:t>
            </a:r>
            <a:r>
              <a:rPr kumimoji="1" lang="en-US" altLang="ja-JP" sz="1400" dirty="0"/>
              <a:t>, adenovirus; RV, rhinovirus; EV, enterovirus; RSV, respiratory syncytial virus; MPV, human metapneumovirus; PIV, para </a:t>
            </a:r>
            <a:r>
              <a:rPr kumimoji="1" lang="en-US" altLang="ja-JP" sz="1400" dirty="0" err="1"/>
              <a:t>influenzavirus</a:t>
            </a:r>
            <a:r>
              <a:rPr kumimoji="1" lang="en-US" altLang="ja-JP" sz="1400" dirty="0"/>
              <a:t>; IFV, influenza virus. </a:t>
            </a:r>
          </a:p>
        </p:txBody>
      </p:sp>
    </p:spTree>
    <p:extLst>
      <p:ext uri="{BB962C8B-B14F-4D97-AF65-F5344CB8AC3E}">
        <p14:creationId xmlns:p14="http://schemas.microsoft.com/office/powerpoint/2010/main" val="34077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</TotalTime>
  <Words>57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tani kanako</dc:creator>
  <cp:lastModifiedBy>Pon Abirami A.</cp:lastModifiedBy>
  <cp:revision>3</cp:revision>
  <dcterms:created xsi:type="dcterms:W3CDTF">2022-02-10T14:41:39Z</dcterms:created>
  <dcterms:modified xsi:type="dcterms:W3CDTF">2022-03-23T04:11:24Z</dcterms:modified>
</cp:coreProperties>
</file>